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68082-F69F-4141-BC89-D7DD1B25FF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59110A-3347-42A1-91FF-D1C802BE61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62240F-6919-4F7A-8B27-EFDF6A1F4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F14A9-7AB6-491F-9084-534E0A90E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1074F-A66F-46FC-9591-AE0341476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85033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954725-E317-4CA1-81F9-687337761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87FEF1-49F6-4B1E-86BB-C972B5075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162EF-491B-401D-92AF-9383B4954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A98B85-EABD-41F0-A206-89753C54B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8E4E2-8D13-4207-B2B7-9D7A5484D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265506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696AC8-4478-480F-8942-D25821CD77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C23BE4-DC89-49D9-B6FE-10369DDAB4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42CF8C-FCFC-430A-A26C-CC29FDF5C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0EFB82-94E2-4049-B67C-A1E2EBB97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1A51EF-4342-46BB-900B-B7F7958B2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2683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9CE37-05CF-49E4-8D05-2F057FF2C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F6A81C-6EBD-46FA-92A1-DE51CFB187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81D37D-F65F-4D10-8523-19EDDBB07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31D37A-F203-4230-801E-9E888B9CA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E278A-340E-4219-8F78-56AB79F12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95473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EB891-DC65-4AAE-B222-8B7360DA2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607135-1C97-4F2F-BC40-DD48D93013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CEF43-62E1-4172-B12E-211D16A09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CF96D0-16BE-4B47-BE6E-678164DFB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F360E-4EE8-4A36-9E65-245E94624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302760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D81C47-47B3-4FE1-9389-6333FFEA40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B785CC-C0DB-4033-BCC8-945BA72EEA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D73280-0AD3-4B44-9600-33A6309744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09ACEA-0488-4578-A754-E623774F0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2652B4-B415-4F9A-87D3-3154D3154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FE7746-C8C7-4D2E-9130-C21A442D0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02274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ECAE8-CC62-46BA-B33D-0680161F6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6F6E72-7570-40D0-A3B7-B6705E9E2C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47B5AE-86D3-46CD-91F5-8E6A80E4DF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C1A99A-D9A3-4D4E-AE91-9F49D2139D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921F3E5-56A6-4887-9449-4758DA35EE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A53E23-65F2-4EDF-8469-1B80038CE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5E42C5-742E-46E4-B158-4AC941B1B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07DF99-D85E-4D59-83E3-BCF5762CD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3564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561EB8-98F7-4AE1-B0B7-24B45B01FF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A70E22-2A25-43D0-9534-DDBE3A24A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2095A2-4047-4654-AA73-4329724F0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4F88A6-0351-47FB-8091-70518076C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996383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F2B6A2-1A3E-4AB7-A855-5DFF84B65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BAC7BE-27DA-4B6E-A721-1167EAD09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318FBB-195A-4067-984A-626716084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22784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8371C-3063-42DE-A3FE-64DB9D60B4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0639F7-D2BE-4B91-9A07-87CBE77FBC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6924D9-7074-47A4-B23C-CCC57AFB97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DB6EE6-8352-4356-A6C9-C57C6CABA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96799B-675E-4B60-AB2C-524E2B450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CECB42-4DF1-49AE-A3FE-A943AB5BB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16541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2E12E8-7C7C-4640-A3E8-590702980F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1FA96D-BF34-4106-B2D6-D68BF14A28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91ED9E-5839-41CE-8BB7-E169EEC6DB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AA9195-8E0D-4DA2-8D3F-0A1452845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27261C-ACB6-47DD-8AB5-C9B66FE54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9B999C-B943-4D39-B158-924727BCF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739459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1A3730-2EC0-4619-B2B3-955FFDA68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DE14B-7DD7-47D8-AB4C-11A6C8321E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354901-7055-4BE1-AA93-349BF2D608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FE28C-DF3D-4D84-A633-25D3D69F3470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CA7250-EBA0-41F3-9243-8BB2A63A96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7C2781-3508-4FF8-A853-8637D73C1B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9FE3F-0E0D-4CFF-BBE7-3D5752DD4BE8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93721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9046182-176F-4EB5-B6AD-F545F4DCA9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348" y="1409699"/>
            <a:ext cx="10561997" cy="45464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8732073-4B58-605C-00F1-7F7003FDB9F7}"/>
              </a:ext>
            </a:extLst>
          </p:cNvPr>
          <p:cNvSpPr txBox="1"/>
          <p:nvPr/>
        </p:nvSpPr>
        <p:spPr>
          <a:xfrm>
            <a:off x="2164359" y="1208015"/>
            <a:ext cx="58387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2a. Reference range of WBC, RBC, HGB, HCT, MCV, MCH, MCHC for healthy bo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1455510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708247D-3113-429F-A021-2B746A6739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0777" y="1033462"/>
            <a:ext cx="9607721" cy="515761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27051CD-D08D-9B8C-3D36-853E15103C68}"/>
              </a:ext>
            </a:extLst>
          </p:cNvPr>
          <p:cNvSpPr txBox="1"/>
          <p:nvPr/>
        </p:nvSpPr>
        <p:spPr>
          <a:xfrm>
            <a:off x="2952924" y="1929468"/>
            <a:ext cx="6702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2b. Reference range of PLT, RDW SD, RDW CV, PDW, MPV, PCT, neutrophil, lymphocyte for healthy bo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3336383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AE2431F-7325-4A1D-8F18-6A1961DADC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6943" y="1119186"/>
            <a:ext cx="9542541" cy="50802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38B8237-93C8-0DD9-6D6A-342C002F08BB}"/>
              </a:ext>
            </a:extLst>
          </p:cNvPr>
          <p:cNvSpPr txBox="1"/>
          <p:nvPr/>
        </p:nvSpPr>
        <p:spPr>
          <a:xfrm>
            <a:off x="2706847" y="2080470"/>
            <a:ext cx="75277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2c. Reference range of monocyte, eosinophil, eosinophil </a:t>
            </a:r>
            <a:r>
              <a:rPr lang="en-ID" dirty="0" err="1"/>
              <a:t>absolut</a:t>
            </a:r>
            <a:r>
              <a:rPr lang="en-ID" dirty="0"/>
              <a:t>, basophil, basophil </a:t>
            </a:r>
            <a:r>
              <a:rPr lang="en-ID" dirty="0" err="1"/>
              <a:t>absolut</a:t>
            </a:r>
            <a:r>
              <a:rPr lang="en-ID" dirty="0"/>
              <a:t>, IPF, IG, RPI for healthy bo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3768841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7A9B28A-4DFA-4532-AC1E-F9DB88B263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2986" y="671974"/>
            <a:ext cx="6953076" cy="53083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1EF7B7A-9676-FF66-BEBD-F5CAB0FCB8CF}"/>
              </a:ext>
            </a:extLst>
          </p:cNvPr>
          <p:cNvSpPr txBox="1"/>
          <p:nvPr/>
        </p:nvSpPr>
        <p:spPr>
          <a:xfrm>
            <a:off x="4186106" y="1593908"/>
            <a:ext cx="56457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/>
              <a:t>Table 2d</a:t>
            </a:r>
            <a:r>
              <a:rPr lang="en-ID" dirty="0"/>
              <a:t>. Reference range of IRF,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 for healthy bo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3418009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11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4</cp:revision>
  <dcterms:created xsi:type="dcterms:W3CDTF">2022-02-16T21:23:15Z</dcterms:created>
  <dcterms:modified xsi:type="dcterms:W3CDTF">2022-07-23T22:28:17Z</dcterms:modified>
</cp:coreProperties>
</file>